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mann Steiner" userId="975aa4c944a0f173" providerId="LiveId" clId="{C50A5575-E3BE-4AFF-BD4F-44A7BF01DFA8}"/>
    <pc:docChg chg="undo custSel modSld">
      <pc:chgData name="Normann Steiner" userId="975aa4c944a0f173" providerId="LiveId" clId="{C50A5575-E3BE-4AFF-BD4F-44A7BF01DFA8}" dt="2024-03-14T18:21:03.279" v="44" actId="20577"/>
      <pc:docMkLst>
        <pc:docMk/>
      </pc:docMkLst>
      <pc:sldChg chg="addSp delSp modSp mod">
        <pc:chgData name="Normann Steiner" userId="975aa4c944a0f173" providerId="LiveId" clId="{C50A5575-E3BE-4AFF-BD4F-44A7BF01DFA8}" dt="2024-03-14T18:21:03.279" v="44" actId="20577"/>
        <pc:sldMkLst>
          <pc:docMk/>
          <pc:sldMk cId="589820511" sldId="256"/>
        </pc:sldMkLst>
        <pc:spChg chg="add mod">
          <ac:chgData name="Normann Steiner" userId="975aa4c944a0f173" providerId="LiveId" clId="{C50A5575-E3BE-4AFF-BD4F-44A7BF01DFA8}" dt="2024-03-14T18:04:26.088" v="2" actId="20577"/>
          <ac:spMkLst>
            <pc:docMk/>
            <pc:sldMk cId="589820511" sldId="256"/>
            <ac:spMk id="2" creationId="{FF7E0229-9E62-B5B1-FD4B-67F6F15A9724}"/>
          </ac:spMkLst>
        </pc:spChg>
        <pc:spChg chg="add del">
          <ac:chgData name="Normann Steiner" userId="975aa4c944a0f173" providerId="LiveId" clId="{C50A5575-E3BE-4AFF-BD4F-44A7BF01DFA8}" dt="2024-03-14T18:18:16.488" v="30" actId="478"/>
          <ac:spMkLst>
            <pc:docMk/>
            <pc:sldMk cId="589820511" sldId="256"/>
            <ac:spMk id="4" creationId="{8F7F6F30-3EF2-B4C6-E16E-68FB84E9AC28}"/>
          </ac:spMkLst>
        </pc:spChg>
        <pc:spChg chg="mod">
          <ac:chgData name="Normann Steiner" userId="975aa4c944a0f173" providerId="LiveId" clId="{C50A5575-E3BE-4AFF-BD4F-44A7BF01DFA8}" dt="2024-03-14T18:18:36.902" v="31" actId="1076"/>
          <ac:spMkLst>
            <pc:docMk/>
            <pc:sldMk cId="589820511" sldId="256"/>
            <ac:spMk id="6" creationId="{B9D9F33D-D01B-7DC8-3FAB-2E3A2BCC93F7}"/>
          </ac:spMkLst>
        </pc:spChg>
        <pc:spChg chg="add mod">
          <ac:chgData name="Normann Steiner" userId="975aa4c944a0f173" providerId="LiveId" clId="{C50A5575-E3BE-4AFF-BD4F-44A7BF01DFA8}" dt="2024-03-14T18:17:20.846" v="25" actId="20577"/>
          <ac:spMkLst>
            <pc:docMk/>
            <pc:sldMk cId="589820511" sldId="256"/>
            <ac:spMk id="7" creationId="{95F845B8-A724-88F6-77C8-DBB0F235F6CC}"/>
          </ac:spMkLst>
        </pc:spChg>
        <pc:spChg chg="add mod ord">
          <ac:chgData name="Normann Steiner" userId="975aa4c944a0f173" providerId="LiveId" clId="{C50A5575-E3BE-4AFF-BD4F-44A7BF01DFA8}" dt="2024-03-14T18:19:23.939" v="36" actId="166"/>
          <ac:spMkLst>
            <pc:docMk/>
            <pc:sldMk cId="589820511" sldId="256"/>
            <ac:spMk id="18" creationId="{5C1A3B9C-A1DF-BDA6-2D3D-9F1E131174B6}"/>
          </ac:spMkLst>
        </pc:spChg>
        <pc:spChg chg="add mod">
          <ac:chgData name="Normann Steiner" userId="975aa4c944a0f173" providerId="LiveId" clId="{C50A5575-E3BE-4AFF-BD4F-44A7BF01DFA8}" dt="2024-03-14T18:21:03.279" v="44" actId="20577"/>
          <ac:spMkLst>
            <pc:docMk/>
            <pc:sldMk cId="589820511" sldId="256"/>
            <ac:spMk id="19" creationId="{1229627B-AEA3-1B88-EEE4-46B30146D14B}"/>
          </ac:spMkLst>
        </pc:spChg>
        <pc:picChg chg="mod">
          <ac:chgData name="Normann Steiner" userId="975aa4c944a0f173" providerId="LiveId" clId="{C50A5575-E3BE-4AFF-BD4F-44A7BF01DFA8}" dt="2024-03-14T18:16:57.207" v="8" actId="1076"/>
          <ac:picMkLst>
            <pc:docMk/>
            <pc:sldMk cId="589820511" sldId="256"/>
            <ac:picMk id="5" creationId="{094C48F2-6565-D839-D3DB-5704E5B81B51}"/>
          </ac:picMkLst>
        </pc:picChg>
        <pc:picChg chg="add mod">
          <ac:chgData name="Normann Steiner" userId="975aa4c944a0f173" providerId="LiveId" clId="{C50A5575-E3BE-4AFF-BD4F-44A7BF01DFA8}" dt="2024-03-14T18:17:56.828" v="27" actId="1076"/>
          <ac:picMkLst>
            <pc:docMk/>
            <pc:sldMk cId="589820511" sldId="256"/>
            <ac:picMk id="13" creationId="{C5B9BD76-9D7C-5B2B-EB95-2E6E9E34D355}"/>
          </ac:picMkLst>
        </pc:picChg>
        <pc:cxnChg chg="ord">
          <ac:chgData name="Normann Steiner" userId="975aa4c944a0f173" providerId="LiveId" clId="{C50A5575-E3BE-4AFF-BD4F-44A7BF01DFA8}" dt="2024-03-14T18:19:31.242" v="37" actId="166"/>
          <ac:cxnSpMkLst>
            <pc:docMk/>
            <pc:sldMk cId="589820511" sldId="256"/>
            <ac:cxnSpMk id="16" creationId="{A2B04E68-25C5-B3ED-E621-F67BE0B98F04}"/>
          </ac:cxnSpMkLst>
        </pc:cxnChg>
        <pc:cxnChg chg="mod ord">
          <ac:chgData name="Normann Steiner" userId="975aa4c944a0f173" providerId="LiveId" clId="{C50A5575-E3BE-4AFF-BD4F-44A7BF01DFA8}" dt="2024-03-14T18:19:37.277" v="38" actId="166"/>
          <ac:cxnSpMkLst>
            <pc:docMk/>
            <pc:sldMk cId="589820511" sldId="256"/>
            <ac:cxnSpMk id="17" creationId="{AE493F71-292F-2147-C2D3-B6A9287D6DB2}"/>
          </ac:cxnSpMkLst>
        </pc:cxnChg>
      </pc:sldChg>
    </pc:docChg>
  </pc:docChgLst>
  <pc:docChgLst>
    <pc:chgData name="Normann Steiner" userId="975aa4c944a0f173" providerId="LiveId" clId="{3C23917C-F613-4D6D-8FDA-A1EE34F3B24C}"/>
    <pc:docChg chg="modSld">
      <pc:chgData name="Normann Steiner" userId="975aa4c944a0f173" providerId="LiveId" clId="{3C23917C-F613-4D6D-8FDA-A1EE34F3B24C}" dt="2024-03-27T17:07:31.699" v="14" actId="14100"/>
      <pc:docMkLst>
        <pc:docMk/>
      </pc:docMkLst>
      <pc:sldChg chg="modSp mod">
        <pc:chgData name="Normann Steiner" userId="975aa4c944a0f173" providerId="LiveId" clId="{3C23917C-F613-4D6D-8FDA-A1EE34F3B24C}" dt="2024-03-27T17:07:31.699" v="14" actId="14100"/>
        <pc:sldMkLst>
          <pc:docMk/>
          <pc:sldMk cId="1199513675" sldId="257"/>
        </pc:sldMkLst>
        <pc:spChg chg="mod">
          <ac:chgData name="Normann Steiner" userId="975aa4c944a0f173" providerId="LiveId" clId="{3C23917C-F613-4D6D-8FDA-A1EE34F3B24C}" dt="2024-03-27T17:07:31.699" v="14" actId="14100"/>
          <ac:spMkLst>
            <pc:docMk/>
            <pc:sldMk cId="1199513675" sldId="257"/>
            <ac:spMk id="5" creationId="{906A9770-5424-9F22-EE4D-F859C66A8F86}"/>
          </ac:spMkLst>
        </pc:spChg>
      </pc:sldChg>
    </pc:docChg>
  </pc:docChgLst>
  <pc:docChgLst>
    <pc:chgData name="Normann Steiner" userId="975aa4c944a0f173" providerId="LiveId" clId="{C68D03AB-8BE2-4F90-8ECB-8A17EA04B90E}"/>
    <pc:docChg chg="custSel addSld delSld modSld">
      <pc:chgData name="Normann Steiner" userId="975aa4c944a0f173" providerId="LiveId" clId="{C68D03AB-8BE2-4F90-8ECB-8A17EA04B90E}" dt="2024-05-20T05:15:29.956" v="99" actId="20577"/>
      <pc:docMkLst>
        <pc:docMk/>
      </pc:docMkLst>
      <pc:sldChg chg="delSp del mod">
        <pc:chgData name="Normann Steiner" userId="975aa4c944a0f173" providerId="LiveId" clId="{C68D03AB-8BE2-4F90-8ECB-8A17EA04B90E}" dt="2024-05-19T04:59:05.768" v="85" actId="47"/>
        <pc:sldMkLst>
          <pc:docMk/>
          <pc:sldMk cId="1199513675" sldId="257"/>
        </pc:sldMkLst>
        <pc:picChg chg="del">
          <ac:chgData name="Normann Steiner" userId="975aa4c944a0f173" providerId="LiveId" clId="{C68D03AB-8BE2-4F90-8ECB-8A17EA04B90E}" dt="2024-05-19T04:59:03.610" v="84" actId="478"/>
          <ac:picMkLst>
            <pc:docMk/>
            <pc:sldMk cId="1199513675" sldId="257"/>
            <ac:picMk id="3" creationId="{1823E54A-9046-B272-39A8-525236FCB079}"/>
          </ac:picMkLst>
        </pc:picChg>
      </pc:sldChg>
      <pc:sldChg chg="addSp modSp new mod">
        <pc:chgData name="Normann Steiner" userId="975aa4c944a0f173" providerId="LiveId" clId="{C68D03AB-8BE2-4F90-8ECB-8A17EA04B90E}" dt="2024-05-20T05:15:29.956" v="99" actId="20577"/>
        <pc:sldMkLst>
          <pc:docMk/>
          <pc:sldMk cId="11655867" sldId="258"/>
        </pc:sldMkLst>
        <pc:spChg chg="add mod">
          <ac:chgData name="Normann Steiner" userId="975aa4c944a0f173" providerId="LiveId" clId="{C68D03AB-8BE2-4F90-8ECB-8A17EA04B90E}" dt="2024-05-19T05:28:50.010" v="88" actId="1076"/>
          <ac:spMkLst>
            <pc:docMk/>
            <pc:sldMk cId="11655867" sldId="258"/>
            <ac:spMk id="4" creationId="{B1F49947-7A5B-2ECC-7B9F-3D9674FB7A48}"/>
          </ac:spMkLst>
        </pc:spChg>
        <pc:spChg chg="add mod">
          <ac:chgData name="Normann Steiner" userId="975aa4c944a0f173" providerId="LiveId" clId="{C68D03AB-8BE2-4F90-8ECB-8A17EA04B90E}" dt="2024-05-20T05:15:29.956" v="99" actId="20577"/>
          <ac:spMkLst>
            <pc:docMk/>
            <pc:sldMk cId="11655867" sldId="258"/>
            <ac:spMk id="5" creationId="{0BA6EEED-5765-C10D-E498-CBB008C6F8DB}"/>
          </ac:spMkLst>
        </pc:spChg>
        <pc:spChg chg="add mod">
          <ac:chgData name="Normann Steiner" userId="975aa4c944a0f173" providerId="LiveId" clId="{C68D03AB-8BE2-4F90-8ECB-8A17EA04B90E}" dt="2024-05-19T04:58:42.183" v="82" actId="1076"/>
          <ac:spMkLst>
            <pc:docMk/>
            <pc:sldMk cId="11655867" sldId="258"/>
            <ac:spMk id="6" creationId="{1C78D3D0-41F6-46BD-99F8-6704A66D63E3}"/>
          </ac:spMkLst>
        </pc:spChg>
        <pc:picChg chg="add mod modCrop">
          <ac:chgData name="Normann Steiner" userId="975aa4c944a0f173" providerId="LiveId" clId="{C68D03AB-8BE2-4F90-8ECB-8A17EA04B90E}" dt="2024-05-19T05:28:39.939" v="86" actId="1076"/>
          <ac:picMkLst>
            <pc:docMk/>
            <pc:sldMk cId="11655867" sldId="258"/>
            <ac:picMk id="3" creationId="{EAE85D5B-0AFC-6030-AE57-40567DABDDA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8D72C-FD02-7268-8CE1-CEEB1998E0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5D67B2-75E1-DCF6-CFE9-633E3B76A7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42422A-79C0-1B27-F36F-1EAEE801D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E558DA-059C-7062-0978-752DAE032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F16010-FAF5-738A-7C8D-F08BFCC74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5535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85E2D-61FF-B3CB-4B00-8BB787392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89E3F5-DBE1-8357-76D2-2962BDAB8B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8224F9-CC7A-46E8-60D4-EB13C430C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515AE5-A612-5CB1-9940-5F1DBBB90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4EAD06-8140-AD2A-AD43-78FFFCAB2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0111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8BA11D-F7C2-39BD-84BF-24E0096F32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CC0860-7016-C673-6C0A-CD7B5A41CA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47496-7F7E-0901-D018-22B5C5035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2AFC27-552A-18CA-4CDA-270BF6EEF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5219EA-454E-C008-E721-F36AAC082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168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A5407-F208-2233-B3DD-BFBE778ED1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0E3F9E-9DC3-A278-90BF-C782D9B424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0F7DDF-45AB-D469-8F0B-0F429EF2F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547C4-AC0E-CA09-D563-5DF00E5D8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1FBA3F-45DC-CF7C-0EB4-4ECB0B1D2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9656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7B772-D03B-35EB-BA13-60679B05B0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F833AB-F076-6773-3D73-B06636DE3D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4B525-2F90-4587-2A4A-BFC75F2EF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C6CB5-F504-BF94-0FD0-051DA05C2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9AFB59-3C48-5023-53DE-2F04D8758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7262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895DC7-AF3A-31E8-E351-383052829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D4BEB6-047B-0570-B7AC-1365D5A5BF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7A4BB0-3133-B65A-CE86-B398067673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9E9D32-BEF6-1093-5AB3-AB65D3BAC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4BEFE9-B4D7-336D-C036-FC8460000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1BC65C-75B0-4323-2AA0-46D9822B0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7662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3EF3F2-54ED-1941-574B-3239B71CF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C12B34-C6C0-A301-A5B2-01116DBCE8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A0B2CA-21BD-BC88-A538-D310F1950F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231875-1DB1-4466-5D18-5E29571D50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13A21B-5DC7-0372-37F5-62CC56CB03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B227A2-6866-9528-93DA-E5A61CD21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46A98A-9852-0DE9-8B96-77DDD1135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36F6F6-5117-8F7B-ADBB-29256A055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8212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C2E59-C85B-862D-212E-3BE61E7345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CE3603F-CD61-F3B7-01A1-AB77F7698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803BEC6-AB79-4E5D-E5F6-FC3099FAF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CF1A99-65E9-2EB7-FF94-EE19570B5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8637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EE75E4-80CC-9C98-4A14-3D713A617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650419-0F28-B17D-D0B7-1D7494D58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E208B8-313D-2920-B99E-165800E7F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8702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D5413-CBAC-3BFC-9139-60EA25DD9E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8762C-76C5-DCF4-2177-2BDAF59EB3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BF0863-43F2-D6ED-9947-83DA028837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778055-4570-E519-4A0F-21B33FCE6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69A0F3-7059-0284-5F19-2B6DA06A7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4F6EA2-A043-E9B1-9451-74BCBEB26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52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C1631-96D9-0330-DF41-275B5116D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2709C-775F-930E-CC36-06F767CAC6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B97C34-DA2F-174E-10A6-82863644B8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5099C8-3254-C2B6-9A04-7B8CD8690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FA62AA-FD3F-9A20-94BB-4A816BEE0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BEB7CC-100E-96F4-46F4-91F7A4712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8829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75F488-D710-E6AC-2553-4EEC9793D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24649F-9006-15BF-BC7D-EC2365993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31226F-421B-2AD8-19A0-20F3D158D2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6F1D39-77AC-4253-B49D-5961B8BD6AD9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FC2193-E529-328F-7281-374054E6CD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5B7BB-2BE5-F07F-E3A6-D9C42CAAEA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DE76AF4-0A38-4C61-B14B-7DB7C4BDD8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819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EAE85D5B-0AFC-6030-AE57-40567DABDD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56" b="12680"/>
          <a:stretch/>
        </p:blipFill>
        <p:spPr>
          <a:xfrm>
            <a:off x="0" y="1805636"/>
            <a:ext cx="12192000" cy="5038165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B1F49947-7A5B-2ECC-7B9F-3D9674FB7A48}"/>
              </a:ext>
            </a:extLst>
          </p:cNvPr>
          <p:cNvSpPr txBox="1"/>
          <p:nvPr/>
        </p:nvSpPr>
        <p:spPr>
          <a:xfrm>
            <a:off x="176784" y="148490"/>
            <a:ext cx="3328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000" b="1" dirty="0" err="1"/>
              <a:t>Supplementary</a:t>
            </a:r>
            <a:r>
              <a:rPr lang="de-AT" sz="2000" b="1" dirty="0"/>
              <a:t> Figure 3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0BA6EEED-5765-C10D-E498-CBB008C6F8DB}"/>
              </a:ext>
            </a:extLst>
          </p:cNvPr>
          <p:cNvSpPr txBox="1">
            <a:spLocks/>
          </p:cNvSpPr>
          <p:nvPr/>
        </p:nvSpPr>
        <p:spPr>
          <a:xfrm>
            <a:off x="1237130" y="41430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800" b="1" dirty="0" err="1">
                <a:latin typeface="+mn-lt"/>
                <a:ea typeface="+mn-ea"/>
                <a:cs typeface="+mn-cs"/>
              </a:rPr>
              <a:t>Propensity</a:t>
            </a:r>
            <a:r>
              <a:rPr lang="de-DE" sz="2800" b="1" dirty="0">
                <a:latin typeface="+mn-lt"/>
                <a:ea typeface="+mn-ea"/>
                <a:cs typeface="+mn-cs"/>
              </a:rPr>
              <a:t> Score </a:t>
            </a:r>
            <a:r>
              <a:rPr lang="de-DE" sz="2800" b="1" dirty="0" err="1">
                <a:latin typeface="+mn-lt"/>
                <a:ea typeface="+mn-ea"/>
                <a:cs typeface="+mn-cs"/>
              </a:rPr>
              <a:t>matched</a:t>
            </a:r>
            <a:r>
              <a:rPr lang="de-DE" sz="2800" b="1" dirty="0">
                <a:latin typeface="+mn-lt"/>
                <a:ea typeface="+mn-ea"/>
                <a:cs typeface="+mn-cs"/>
              </a:rPr>
              <a:t> </a:t>
            </a:r>
          </a:p>
          <a:p>
            <a:r>
              <a:rPr lang="de-DE" sz="2800" b="1" dirty="0" err="1">
                <a:latin typeface="+mn-lt"/>
                <a:ea typeface="+mn-ea"/>
                <a:cs typeface="+mn-cs"/>
              </a:rPr>
              <a:t>Cumulative</a:t>
            </a:r>
            <a:r>
              <a:rPr lang="de-DE" sz="2800" b="1" dirty="0">
                <a:latin typeface="+mn-lt"/>
                <a:ea typeface="+mn-ea"/>
                <a:cs typeface="+mn-cs"/>
              </a:rPr>
              <a:t> </a:t>
            </a:r>
            <a:r>
              <a:rPr lang="de-DE" sz="2800" b="1" dirty="0" err="1">
                <a:latin typeface="+mn-lt"/>
                <a:ea typeface="+mn-ea"/>
                <a:cs typeface="+mn-cs"/>
              </a:rPr>
              <a:t>incidence</a:t>
            </a:r>
            <a:r>
              <a:rPr lang="de-DE" sz="2800" b="1" dirty="0">
                <a:latin typeface="+mn-lt"/>
                <a:ea typeface="+mn-ea"/>
                <a:cs typeface="+mn-cs"/>
              </a:rPr>
              <a:t> </a:t>
            </a:r>
            <a:r>
              <a:rPr lang="de-DE" sz="2800" b="1" dirty="0" err="1">
                <a:latin typeface="+mn-lt"/>
                <a:ea typeface="+mn-ea"/>
                <a:cs typeface="+mn-cs"/>
              </a:rPr>
              <a:t>of</a:t>
            </a:r>
            <a:r>
              <a:rPr lang="de-DE" sz="2800" b="1" dirty="0">
                <a:latin typeface="+mn-lt"/>
                <a:ea typeface="+mn-ea"/>
                <a:cs typeface="+mn-cs"/>
              </a:rPr>
              <a:t> </a:t>
            </a:r>
            <a:r>
              <a:rPr lang="de-DE" sz="2800" b="1" dirty="0" err="1">
                <a:latin typeface="+mn-lt"/>
                <a:ea typeface="+mn-ea"/>
                <a:cs typeface="+mn-cs"/>
              </a:rPr>
              <a:t>aGvHD</a:t>
            </a:r>
            <a:r>
              <a:rPr lang="de-DE" sz="2800" b="1">
                <a:latin typeface="+mn-lt"/>
                <a:ea typeface="+mn-ea"/>
                <a:cs typeface="+mn-cs"/>
              </a:rPr>
              <a:t> grades II-IV</a:t>
            </a:r>
            <a:endParaRPr lang="de-DE" sz="2800" b="1" dirty="0">
              <a:latin typeface="+mn-lt"/>
              <a:ea typeface="+mn-ea"/>
              <a:cs typeface="+mn-cs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1C78D3D0-41F6-46BD-99F8-6704A66D63E3}"/>
              </a:ext>
            </a:extLst>
          </p:cNvPr>
          <p:cNvSpPr txBox="1"/>
          <p:nvPr/>
        </p:nvSpPr>
        <p:spPr>
          <a:xfrm>
            <a:off x="2366683" y="4906606"/>
            <a:ext cx="1039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600" dirty="0"/>
              <a:t>p = 0.07</a:t>
            </a:r>
          </a:p>
        </p:txBody>
      </p:sp>
    </p:spTree>
    <p:extLst>
      <p:ext uri="{BB962C8B-B14F-4D97-AF65-F5344CB8AC3E}">
        <p14:creationId xmlns:p14="http://schemas.microsoft.com/office/powerpoint/2010/main" val="11655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wan massoud</dc:creator>
  <cp:lastModifiedBy>Normann Steiner</cp:lastModifiedBy>
  <cp:revision>3</cp:revision>
  <dcterms:created xsi:type="dcterms:W3CDTF">2024-03-13T20:08:31Z</dcterms:created>
  <dcterms:modified xsi:type="dcterms:W3CDTF">2024-05-20T05:15:32Z</dcterms:modified>
</cp:coreProperties>
</file>